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915" autoAdjust="0"/>
  </p:normalViewPr>
  <p:slideViewPr>
    <p:cSldViewPr snapToGrid="0">
      <p:cViewPr varScale="1">
        <p:scale>
          <a:sx n="97" d="100"/>
          <a:sy n="97" d="100"/>
        </p:scale>
        <p:origin x="442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ttmar Janssen" userId="70344527451028a5" providerId="LiveId" clId="{5D197BF3-C9CE-480D-98F0-66C4AB62FFAA}"/>
    <pc:docChg chg="modSld">
      <pc:chgData name="Ottmar Janssen" userId="70344527451028a5" providerId="LiveId" clId="{5D197BF3-C9CE-480D-98F0-66C4AB62FFAA}" dt="2024-10-16T13:34:22.885" v="1" actId="20577"/>
      <pc:docMkLst>
        <pc:docMk/>
      </pc:docMkLst>
      <pc:sldChg chg="modSp mod">
        <pc:chgData name="Ottmar Janssen" userId="70344527451028a5" providerId="LiveId" clId="{5D197BF3-C9CE-480D-98F0-66C4AB62FFAA}" dt="2024-10-16T13:34:22.885" v="1" actId="20577"/>
        <pc:sldMkLst>
          <pc:docMk/>
          <pc:sldMk cId="975866060" sldId="258"/>
        </pc:sldMkLst>
        <pc:spChg chg="mod">
          <ac:chgData name="Ottmar Janssen" userId="70344527451028a5" providerId="LiveId" clId="{5D197BF3-C9CE-480D-98F0-66C4AB62FFAA}" dt="2024-10-16T13:34:22.885" v="1" actId="20577"/>
          <ac:spMkLst>
            <pc:docMk/>
            <pc:sldMk cId="975866060" sldId="258"/>
            <ac:spMk id="2" creationId="{BC015917-0693-7275-7B03-A074FF6F6E21}"/>
          </ac:spMkLst>
        </pc:spChg>
      </pc:sldChg>
    </pc:docChg>
  </pc:docChgLst>
  <pc:docChgLst>
    <pc:chgData name="Ottmar Janssen" userId="70344527451028a5" providerId="LiveId" clId="{FE343503-40EE-44F4-B500-57E57A0105B8}"/>
    <pc:docChg chg="custSel modSld">
      <pc:chgData name="Ottmar Janssen" userId="70344527451028a5" providerId="LiveId" clId="{FE343503-40EE-44F4-B500-57E57A0105B8}" dt="2024-08-17T14:12:02.611" v="0" actId="478"/>
      <pc:docMkLst>
        <pc:docMk/>
      </pc:docMkLst>
      <pc:sldChg chg="delSp mod">
        <pc:chgData name="Ottmar Janssen" userId="70344527451028a5" providerId="LiveId" clId="{FE343503-40EE-44F4-B500-57E57A0105B8}" dt="2024-08-17T14:12:02.611" v="0" actId="478"/>
        <pc:sldMkLst>
          <pc:docMk/>
          <pc:sldMk cId="975866060" sldId="258"/>
        </pc:sldMkLst>
        <pc:spChg chg="del">
          <ac:chgData name="Ottmar Janssen" userId="70344527451028a5" providerId="LiveId" clId="{FE343503-40EE-44F4-B500-57E57A0105B8}" dt="2024-08-17T14:12:02.611" v="0" actId="478"/>
          <ac:spMkLst>
            <pc:docMk/>
            <pc:sldMk cId="975866060" sldId="258"/>
            <ac:spMk id="12" creationId="{03248B54-5F59-3B50-C00E-53B05BEB13BA}"/>
          </ac:spMkLst>
        </pc:spChg>
      </pc:sldChg>
    </pc:docChg>
  </pc:docChgLst>
  <pc:docChgLst>
    <pc:chgData name="Ottmar Janssen" userId="70344527451028a5" providerId="LiveId" clId="{D81278BD-CC1D-4DFB-AA59-3B086819785F}"/>
    <pc:docChg chg="delSld">
      <pc:chgData name="Ottmar Janssen" userId="70344527451028a5" providerId="LiveId" clId="{D81278BD-CC1D-4DFB-AA59-3B086819785F}" dt="2024-08-16T10:24:37.719" v="0" actId="47"/>
      <pc:docMkLst>
        <pc:docMk/>
      </pc:docMkLst>
      <pc:sldChg chg="del">
        <pc:chgData name="Ottmar Janssen" userId="70344527451028a5" providerId="LiveId" clId="{D81278BD-CC1D-4DFB-AA59-3B086819785F}" dt="2024-08-16T10:24:37.719" v="0" actId="47"/>
        <pc:sldMkLst>
          <pc:docMk/>
          <pc:sldMk cId="3163140662" sldId="259"/>
        </pc:sldMkLst>
      </pc:sldChg>
    </pc:docChg>
  </pc:docChgLst>
  <pc:docChgLst>
    <pc:chgData name="Ottmar Janssen" userId="70344527451028a5" providerId="LiveId" clId="{80F0EF5E-60F4-4E34-B484-3A39EBFC76FD}"/>
    <pc:docChg chg="undo custSel modSld">
      <pc:chgData name="Ottmar Janssen" userId="70344527451028a5" providerId="LiveId" clId="{80F0EF5E-60F4-4E34-B484-3A39EBFC76FD}" dt="2024-09-11T10:15:39.354" v="637" actId="1037"/>
      <pc:docMkLst>
        <pc:docMk/>
      </pc:docMkLst>
      <pc:sldChg chg="addSp delSp modSp mod">
        <pc:chgData name="Ottmar Janssen" userId="70344527451028a5" providerId="LiveId" clId="{80F0EF5E-60F4-4E34-B484-3A39EBFC76FD}" dt="2024-09-11T10:15:39.354" v="637" actId="1037"/>
        <pc:sldMkLst>
          <pc:docMk/>
          <pc:sldMk cId="975866060" sldId="258"/>
        </pc:sldMkLst>
        <pc:spChg chg="add mod">
          <ac:chgData name="Ottmar Janssen" userId="70344527451028a5" providerId="LiveId" clId="{80F0EF5E-60F4-4E34-B484-3A39EBFC76FD}" dt="2024-09-11T10:14:55.437" v="630" actId="1076"/>
          <ac:spMkLst>
            <pc:docMk/>
            <pc:sldMk cId="975866060" sldId="258"/>
            <ac:spMk id="2" creationId="{BC015917-0693-7275-7B03-A074FF6F6E21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6" creationId="{3E79A950-F3A8-1CE2-36D7-86DA9632ABA3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7" creationId="{422ED59B-006F-0727-EFAE-812C0C2C5B1A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10" creationId="{3E79A950-F3A8-1CE2-36D7-86DA9632ABA3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11" creationId="{422ED59B-006F-0727-EFAE-812C0C2C5B1A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13" creationId="{785DCF39-B584-22FF-8882-7687ABFC2CBB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14" creationId="{A31D7868-DF71-F0CF-F70D-1C435F54F06E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16" creationId="{EB45D794-55A5-D884-D67D-463E40BF0D4E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17" creationId="{785DCF39-B584-22FF-8882-7687ABFC2CBB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18" creationId="{A31D7868-DF71-F0CF-F70D-1C435F54F06E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19" creationId="{EB45D794-55A5-D884-D67D-463E40BF0D4E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20" creationId="{D69E6951-AEEF-7899-9688-370742044547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23" creationId="{D69E6951-AEEF-7899-9688-370742044547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27" creationId="{B7F0FD24-A110-AC81-EA2B-2E5EBEC979B0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28" creationId="{06E402E2-5BC2-103D-068A-A7BF0FC41208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34" creationId="{61531F5C-9B57-B7A1-DA09-D34E696F0A6A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35" creationId="{C575A34A-E27C-E481-1E37-481F981A450C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36" creationId="{DCF68E70-87D6-346A-A379-C1C0280B4B38}"/>
          </ac:spMkLst>
        </pc:spChg>
        <pc:spChg chg="mod">
          <ac:chgData name="Ottmar Janssen" userId="70344527451028a5" providerId="LiveId" clId="{80F0EF5E-60F4-4E34-B484-3A39EBFC76FD}" dt="2024-09-05T08:54:35.289" v="0" actId="164"/>
          <ac:spMkLst>
            <pc:docMk/>
            <pc:sldMk cId="975866060" sldId="258"/>
            <ac:spMk id="37" creationId="{EDB01EC0-628B-CC51-1139-9C02B52BBE95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42" creationId="{B7F0FD24-A110-AC81-EA2B-2E5EBEC979B0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43" creationId="{06E402E2-5BC2-103D-068A-A7BF0FC41208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48" creationId="{61531F5C-9B57-B7A1-DA09-D34E696F0A6A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49" creationId="{C575A34A-E27C-E481-1E37-481F981A450C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50" creationId="{DCF68E70-87D6-346A-A379-C1C0280B4B38}"/>
          </ac:spMkLst>
        </pc:spChg>
        <pc:spChg chg="mod topLvl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51" creationId="{EDB01EC0-628B-CC51-1139-9C02B52BBE95}"/>
          </ac:spMkLst>
        </pc:spChg>
        <pc:spChg chg="add mod">
          <ac:chgData name="Ottmar Janssen" userId="70344527451028a5" providerId="LiveId" clId="{80F0EF5E-60F4-4E34-B484-3A39EBFC76FD}" dt="2024-09-11T10:15:12.202" v="631" actId="164"/>
          <ac:spMkLst>
            <pc:docMk/>
            <pc:sldMk cId="975866060" sldId="258"/>
            <ac:spMk id="52" creationId="{03A15AC4-838E-8890-E425-A162B4A6334A}"/>
          </ac:spMkLst>
        </pc:spChg>
        <pc:grpChg chg="add del mod">
          <ac:chgData name="Ottmar Janssen" userId="70344527451028a5" providerId="LiveId" clId="{80F0EF5E-60F4-4E34-B484-3A39EBFC76FD}" dt="2024-09-05T09:14:58.913" v="2" actId="21"/>
          <ac:grpSpMkLst>
            <pc:docMk/>
            <pc:sldMk cId="975866060" sldId="258"/>
            <ac:grpSpMk id="2" creationId="{58088817-6C1B-BA60-FDF4-F7146BE73EED}"/>
          </ac:grpSpMkLst>
        </pc:grpChg>
        <pc:grpChg chg="add mod">
          <ac:chgData name="Ottmar Janssen" userId="70344527451028a5" providerId="LiveId" clId="{80F0EF5E-60F4-4E34-B484-3A39EBFC76FD}" dt="2024-09-11T10:15:39.354" v="637" actId="1037"/>
          <ac:grpSpMkLst>
            <pc:docMk/>
            <pc:sldMk cId="975866060" sldId="258"/>
            <ac:grpSpMk id="3" creationId="{F3156BA9-2AC2-3720-D26D-F2D73B9E7F12}"/>
          </ac:grpSpMkLst>
        </pc:grpChg>
        <pc:grpChg chg="add del mod">
          <ac:chgData name="Ottmar Janssen" userId="70344527451028a5" providerId="LiveId" clId="{80F0EF5E-60F4-4E34-B484-3A39EBFC76FD}" dt="2024-09-05T09:16:52.139" v="10" actId="165"/>
          <ac:grpSpMkLst>
            <pc:docMk/>
            <pc:sldMk cId="975866060" sldId="258"/>
            <ac:grpSpMk id="4" creationId="{58088817-6C1B-BA60-FDF4-F7146BE73EED}"/>
          </ac:grpSpMkLst>
        </pc:grpChg>
        <pc:picChg chg="mod">
          <ac:chgData name="Ottmar Janssen" userId="70344527451028a5" providerId="LiveId" clId="{80F0EF5E-60F4-4E34-B484-3A39EBFC76FD}" dt="2024-09-05T08:54:35.289" v="0" actId="164"/>
          <ac:picMkLst>
            <pc:docMk/>
            <pc:sldMk cId="975866060" sldId="258"/>
            <ac:picMk id="3" creationId="{4D92A0AA-ABC8-4161-EC1C-E43B1A41ED13}"/>
          </ac:picMkLst>
        </pc:picChg>
        <pc:picChg chg="mod">
          <ac:chgData name="Ottmar Janssen" userId="70344527451028a5" providerId="LiveId" clId="{80F0EF5E-60F4-4E34-B484-3A39EBFC76FD}" dt="2024-09-05T08:54:35.289" v="0" actId="164"/>
          <ac:picMkLst>
            <pc:docMk/>
            <pc:sldMk cId="975866060" sldId="258"/>
            <ac:picMk id="5" creationId="{68F3B8E4-2ACA-120C-6267-E2A637BADEB3}"/>
          </ac:picMkLst>
        </pc:picChg>
        <pc:picChg chg="mod topLvl">
          <ac:chgData name="Ottmar Janssen" userId="70344527451028a5" providerId="LiveId" clId="{80F0EF5E-60F4-4E34-B484-3A39EBFC76FD}" dt="2024-09-11T10:15:12.202" v="631" actId="164"/>
          <ac:picMkLst>
            <pc:docMk/>
            <pc:sldMk cId="975866060" sldId="258"/>
            <ac:picMk id="8" creationId="{4D92A0AA-ABC8-4161-EC1C-E43B1A41ED13}"/>
          </ac:picMkLst>
        </pc:picChg>
        <pc:picChg chg="mod topLvl">
          <ac:chgData name="Ottmar Janssen" userId="70344527451028a5" providerId="LiveId" clId="{80F0EF5E-60F4-4E34-B484-3A39EBFC76FD}" dt="2024-09-11T10:15:12.202" v="631" actId="164"/>
          <ac:picMkLst>
            <pc:docMk/>
            <pc:sldMk cId="975866060" sldId="258"/>
            <ac:picMk id="9" creationId="{68F3B8E4-2ACA-120C-6267-E2A637BADEB3}"/>
          </ac:picMkLst>
        </pc:picChg>
        <pc:cxnChg chg="mod topLvl">
          <ac:chgData name="Ottmar Janssen" userId="70344527451028a5" providerId="LiveId" clId="{80F0EF5E-60F4-4E34-B484-3A39EBFC76FD}" dt="2024-09-11T10:15:12.202" v="631" actId="164"/>
          <ac:cxnSpMkLst>
            <pc:docMk/>
            <pc:sldMk cId="975866060" sldId="258"/>
            <ac:cxnSpMk id="12" creationId="{83B2D66B-B225-A8CD-C73F-5690C7B63E15}"/>
          </ac:cxnSpMkLst>
        </pc:cxnChg>
        <pc:cxnChg chg="mod">
          <ac:chgData name="Ottmar Janssen" userId="70344527451028a5" providerId="LiveId" clId="{80F0EF5E-60F4-4E34-B484-3A39EBFC76FD}" dt="2024-09-05T08:54:35.289" v="0" actId="164"/>
          <ac:cxnSpMkLst>
            <pc:docMk/>
            <pc:sldMk cId="975866060" sldId="258"/>
            <ac:cxnSpMk id="15" creationId="{83B2D66B-B225-A8CD-C73F-5690C7B63E15}"/>
          </ac:cxnSpMkLst>
        </pc:cxnChg>
        <pc:cxnChg chg="mod">
          <ac:chgData name="Ottmar Janssen" userId="70344527451028a5" providerId="LiveId" clId="{80F0EF5E-60F4-4E34-B484-3A39EBFC76FD}" dt="2024-09-05T08:54:35.289" v="0" actId="164"/>
          <ac:cxnSpMkLst>
            <pc:docMk/>
            <pc:sldMk cId="975866060" sldId="258"/>
            <ac:cxnSpMk id="21" creationId="{1B60227D-2587-E7C4-78AF-6B72207A365D}"/>
          </ac:cxnSpMkLst>
        </pc:cxnChg>
        <pc:cxnChg chg="mod">
          <ac:chgData name="Ottmar Janssen" userId="70344527451028a5" providerId="LiveId" clId="{80F0EF5E-60F4-4E34-B484-3A39EBFC76FD}" dt="2024-09-05T08:54:35.289" v="0" actId="164"/>
          <ac:cxnSpMkLst>
            <pc:docMk/>
            <pc:sldMk cId="975866060" sldId="258"/>
            <ac:cxnSpMk id="22" creationId="{A52B8D8A-A3EE-97FC-F57A-DA0C770E9038}"/>
          </ac:cxnSpMkLst>
        </pc:cxnChg>
        <pc:cxnChg chg="mod">
          <ac:chgData name="Ottmar Janssen" userId="70344527451028a5" providerId="LiveId" clId="{80F0EF5E-60F4-4E34-B484-3A39EBFC76FD}" dt="2024-09-05T08:54:35.289" v="0" actId="164"/>
          <ac:cxnSpMkLst>
            <pc:docMk/>
            <pc:sldMk cId="975866060" sldId="258"/>
            <ac:cxnSpMk id="24" creationId="{ACF8A12A-849A-FAFE-34E0-CC304AE08DBE}"/>
          </ac:cxnSpMkLst>
        </pc:cxnChg>
        <pc:cxnChg chg="mod">
          <ac:chgData name="Ottmar Janssen" userId="70344527451028a5" providerId="LiveId" clId="{80F0EF5E-60F4-4E34-B484-3A39EBFC76FD}" dt="2024-09-05T08:54:35.289" v="0" actId="164"/>
          <ac:cxnSpMkLst>
            <pc:docMk/>
            <pc:sldMk cId="975866060" sldId="258"/>
            <ac:cxnSpMk id="25" creationId="{6311AF1D-C137-8690-43B8-B1CDD4FD002C}"/>
          </ac:cxnSpMkLst>
        </pc:cxnChg>
        <pc:cxnChg chg="mod">
          <ac:chgData name="Ottmar Janssen" userId="70344527451028a5" providerId="LiveId" clId="{80F0EF5E-60F4-4E34-B484-3A39EBFC76FD}" dt="2024-09-05T08:54:35.289" v="0" actId="164"/>
          <ac:cxnSpMkLst>
            <pc:docMk/>
            <pc:sldMk cId="975866060" sldId="258"/>
            <ac:cxnSpMk id="26" creationId="{21CB2835-D2B4-271C-243A-EA8978566248}"/>
          </ac:cxnSpMkLst>
        </pc:cxnChg>
        <pc:cxnChg chg="mod">
          <ac:chgData name="Ottmar Janssen" userId="70344527451028a5" providerId="LiveId" clId="{80F0EF5E-60F4-4E34-B484-3A39EBFC76FD}" dt="2024-09-05T08:54:35.289" v="0" actId="164"/>
          <ac:cxnSpMkLst>
            <pc:docMk/>
            <pc:sldMk cId="975866060" sldId="258"/>
            <ac:cxnSpMk id="29" creationId="{C13BCCE5-A354-F6E2-3669-86B6BBD2BF8D}"/>
          </ac:cxnSpMkLst>
        </pc:cxnChg>
        <pc:cxnChg chg="mod topLvl">
          <ac:chgData name="Ottmar Janssen" userId="70344527451028a5" providerId="LiveId" clId="{80F0EF5E-60F4-4E34-B484-3A39EBFC76FD}" dt="2024-09-11T10:15:12.202" v="631" actId="164"/>
          <ac:cxnSpMkLst>
            <pc:docMk/>
            <pc:sldMk cId="975866060" sldId="258"/>
            <ac:cxnSpMk id="30" creationId="{1B60227D-2587-E7C4-78AF-6B72207A365D}"/>
          </ac:cxnSpMkLst>
        </pc:cxnChg>
        <pc:cxnChg chg="mod">
          <ac:chgData name="Ottmar Janssen" userId="70344527451028a5" providerId="LiveId" clId="{80F0EF5E-60F4-4E34-B484-3A39EBFC76FD}" dt="2024-09-05T08:54:35.289" v="0" actId="164"/>
          <ac:cxnSpMkLst>
            <pc:docMk/>
            <pc:sldMk cId="975866060" sldId="258"/>
            <ac:cxnSpMk id="31" creationId="{49192218-DF11-92A2-4AAD-DDF9B6841A3C}"/>
          </ac:cxnSpMkLst>
        </pc:cxnChg>
        <pc:cxnChg chg="mod">
          <ac:chgData name="Ottmar Janssen" userId="70344527451028a5" providerId="LiveId" clId="{80F0EF5E-60F4-4E34-B484-3A39EBFC76FD}" dt="2024-09-05T08:54:35.289" v="0" actId="164"/>
          <ac:cxnSpMkLst>
            <pc:docMk/>
            <pc:sldMk cId="975866060" sldId="258"/>
            <ac:cxnSpMk id="32" creationId="{FDBE9E43-23E6-DA4A-919A-CBCCA76FECA4}"/>
          </ac:cxnSpMkLst>
        </pc:cxnChg>
        <pc:cxnChg chg="mod">
          <ac:chgData name="Ottmar Janssen" userId="70344527451028a5" providerId="LiveId" clId="{80F0EF5E-60F4-4E34-B484-3A39EBFC76FD}" dt="2024-09-05T08:54:35.289" v="0" actId="164"/>
          <ac:cxnSpMkLst>
            <pc:docMk/>
            <pc:sldMk cId="975866060" sldId="258"/>
            <ac:cxnSpMk id="33" creationId="{096A41FB-C6FA-8107-65C8-2DD32789087D}"/>
          </ac:cxnSpMkLst>
        </pc:cxnChg>
        <pc:cxnChg chg="mod topLvl">
          <ac:chgData name="Ottmar Janssen" userId="70344527451028a5" providerId="LiveId" clId="{80F0EF5E-60F4-4E34-B484-3A39EBFC76FD}" dt="2024-09-11T10:15:12.202" v="631" actId="164"/>
          <ac:cxnSpMkLst>
            <pc:docMk/>
            <pc:sldMk cId="975866060" sldId="258"/>
            <ac:cxnSpMk id="38" creationId="{A52B8D8A-A3EE-97FC-F57A-DA0C770E9038}"/>
          </ac:cxnSpMkLst>
        </pc:cxnChg>
        <pc:cxnChg chg="mod topLvl">
          <ac:chgData name="Ottmar Janssen" userId="70344527451028a5" providerId="LiveId" clId="{80F0EF5E-60F4-4E34-B484-3A39EBFC76FD}" dt="2024-09-11T10:15:12.202" v="631" actId="164"/>
          <ac:cxnSpMkLst>
            <pc:docMk/>
            <pc:sldMk cId="975866060" sldId="258"/>
            <ac:cxnSpMk id="39" creationId="{ACF8A12A-849A-FAFE-34E0-CC304AE08DBE}"/>
          </ac:cxnSpMkLst>
        </pc:cxnChg>
        <pc:cxnChg chg="mod topLvl">
          <ac:chgData name="Ottmar Janssen" userId="70344527451028a5" providerId="LiveId" clId="{80F0EF5E-60F4-4E34-B484-3A39EBFC76FD}" dt="2024-09-11T10:15:12.202" v="631" actId="164"/>
          <ac:cxnSpMkLst>
            <pc:docMk/>
            <pc:sldMk cId="975866060" sldId="258"/>
            <ac:cxnSpMk id="40" creationId="{6311AF1D-C137-8690-43B8-B1CDD4FD002C}"/>
          </ac:cxnSpMkLst>
        </pc:cxnChg>
        <pc:cxnChg chg="mod topLvl">
          <ac:chgData name="Ottmar Janssen" userId="70344527451028a5" providerId="LiveId" clId="{80F0EF5E-60F4-4E34-B484-3A39EBFC76FD}" dt="2024-09-11T10:15:12.202" v="631" actId="164"/>
          <ac:cxnSpMkLst>
            <pc:docMk/>
            <pc:sldMk cId="975866060" sldId="258"/>
            <ac:cxnSpMk id="41" creationId="{21CB2835-D2B4-271C-243A-EA8978566248}"/>
          </ac:cxnSpMkLst>
        </pc:cxnChg>
        <pc:cxnChg chg="mod topLvl">
          <ac:chgData name="Ottmar Janssen" userId="70344527451028a5" providerId="LiveId" clId="{80F0EF5E-60F4-4E34-B484-3A39EBFC76FD}" dt="2024-09-11T10:15:12.202" v="631" actId="164"/>
          <ac:cxnSpMkLst>
            <pc:docMk/>
            <pc:sldMk cId="975866060" sldId="258"/>
            <ac:cxnSpMk id="44" creationId="{C13BCCE5-A354-F6E2-3669-86B6BBD2BF8D}"/>
          </ac:cxnSpMkLst>
        </pc:cxnChg>
        <pc:cxnChg chg="mod topLvl">
          <ac:chgData name="Ottmar Janssen" userId="70344527451028a5" providerId="LiveId" clId="{80F0EF5E-60F4-4E34-B484-3A39EBFC76FD}" dt="2024-09-11T10:15:12.202" v="631" actId="164"/>
          <ac:cxnSpMkLst>
            <pc:docMk/>
            <pc:sldMk cId="975866060" sldId="258"/>
            <ac:cxnSpMk id="45" creationId="{49192218-DF11-92A2-4AAD-DDF9B6841A3C}"/>
          </ac:cxnSpMkLst>
        </pc:cxnChg>
        <pc:cxnChg chg="mod topLvl">
          <ac:chgData name="Ottmar Janssen" userId="70344527451028a5" providerId="LiveId" clId="{80F0EF5E-60F4-4E34-B484-3A39EBFC76FD}" dt="2024-09-11T10:15:12.202" v="631" actId="164"/>
          <ac:cxnSpMkLst>
            <pc:docMk/>
            <pc:sldMk cId="975866060" sldId="258"/>
            <ac:cxnSpMk id="46" creationId="{FDBE9E43-23E6-DA4A-919A-CBCCA76FECA4}"/>
          </ac:cxnSpMkLst>
        </pc:cxnChg>
        <pc:cxnChg chg="mod topLvl">
          <ac:chgData name="Ottmar Janssen" userId="70344527451028a5" providerId="LiveId" clId="{80F0EF5E-60F4-4E34-B484-3A39EBFC76FD}" dt="2024-09-11T10:15:12.202" v="631" actId="164"/>
          <ac:cxnSpMkLst>
            <pc:docMk/>
            <pc:sldMk cId="975866060" sldId="258"/>
            <ac:cxnSpMk id="47" creationId="{096A41FB-C6FA-8107-65C8-2DD32789087D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FF8F20-8999-4EFD-959D-634BF2160D47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2B498C-F3F1-4244-9297-EA0517C4C1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72952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2B498C-F3F1-4244-9297-EA0517C4C12D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79134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6181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8653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8391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5273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0384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33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6054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8038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4731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5229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8931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7276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F3156BA9-2AC2-3720-D26D-F2D73B9E7F12}"/>
              </a:ext>
            </a:extLst>
          </p:cNvPr>
          <p:cNvGrpSpPr/>
          <p:nvPr/>
        </p:nvGrpSpPr>
        <p:grpSpPr>
          <a:xfrm>
            <a:off x="129880" y="583998"/>
            <a:ext cx="6601362" cy="4042593"/>
            <a:chOff x="174750" y="583998"/>
            <a:chExt cx="6601362" cy="4042593"/>
          </a:xfrm>
        </p:grpSpPr>
        <p:pic>
          <p:nvPicPr>
            <p:cNvPr id="8" name="Grafik 7">
              <a:extLst>
                <a:ext uri="{FF2B5EF4-FFF2-40B4-BE49-F238E27FC236}">
                  <a16:creationId xmlns:a16="http://schemas.microsoft.com/office/drawing/2014/main" id="{4D92A0AA-ABC8-4161-EC1C-E43B1A41ED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lum bright="-20000" contrast="-20000"/>
            </a:blip>
            <a:srcRect l="38314" t="69166" r="35647" b="18056"/>
            <a:stretch/>
          </p:blipFill>
          <p:spPr>
            <a:xfrm>
              <a:off x="1500674" y="3349414"/>
              <a:ext cx="3590640" cy="127717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68F3B8E4-2ACA-120C-6267-E2A637BADE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8830" t="55833" r="37260" b="29306"/>
            <a:stretch/>
          </p:blipFill>
          <p:spPr>
            <a:xfrm>
              <a:off x="1500674" y="1881585"/>
              <a:ext cx="3590640" cy="117571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3E79A950-F3A8-1CE2-36D7-86DA9632ABA3}"/>
                </a:ext>
              </a:extLst>
            </p:cNvPr>
            <p:cNvSpPr txBox="1"/>
            <p:nvPr/>
          </p:nvSpPr>
          <p:spPr>
            <a:xfrm>
              <a:off x="1587864" y="584594"/>
              <a:ext cx="159319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DE" b="1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de-DE" b="1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de-DE" b="1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T </a:t>
              </a:r>
              <a:r>
                <a:rPr lang="de-DE" b="1" i="0" u="none" strike="noStrike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r>
                <a:rPr lang="de-DE" b="1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DE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422ED59B-006F-0727-EFAE-812C0C2C5B1A}"/>
                </a:ext>
              </a:extLst>
            </p:cNvPr>
            <p:cNvSpPr txBox="1"/>
            <p:nvPr/>
          </p:nvSpPr>
          <p:spPr>
            <a:xfrm>
              <a:off x="3406963" y="583998"/>
              <a:ext cx="159319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DE" b="1" dirty="0" err="1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γδ</a:t>
              </a:r>
              <a:r>
                <a:rPr lang="de-DE" b="1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de-DE" b="1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T </a:t>
              </a:r>
              <a:r>
                <a:rPr lang="de-DE" b="1" i="0" u="none" strike="noStrike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r>
                <a:rPr lang="de-DE" b="1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DE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Gerader Verbinder 11">
              <a:extLst>
                <a:ext uri="{FF2B5EF4-FFF2-40B4-BE49-F238E27FC236}">
                  <a16:creationId xmlns:a16="http://schemas.microsoft.com/office/drawing/2014/main" id="{83B2D66B-B225-A8CD-C73F-5690C7B63E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07021" y="1739758"/>
              <a:ext cx="69752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785DCF39-B584-22FF-8882-7687ABFC2CBB}"/>
                </a:ext>
              </a:extLst>
            </p:cNvPr>
            <p:cNvSpPr txBox="1"/>
            <p:nvPr/>
          </p:nvSpPr>
          <p:spPr>
            <a:xfrm rot="16200000">
              <a:off x="2499243" y="1146330"/>
              <a:ext cx="81752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b="0" i="0" u="none" strike="noStrike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wcl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A31D7868-DF71-F0CF-F70D-1C435F54F06E}"/>
                </a:ext>
              </a:extLst>
            </p:cNvPr>
            <p:cNvSpPr txBox="1"/>
            <p:nvPr/>
          </p:nvSpPr>
          <p:spPr>
            <a:xfrm rot="16200000">
              <a:off x="4240782" y="1146330"/>
              <a:ext cx="81752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b="0" i="0" u="none" strike="noStrike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wcl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EB45D794-55A5-D884-D67D-463E40BF0D4E}"/>
                </a:ext>
              </a:extLst>
            </p:cNvPr>
            <p:cNvSpPr txBox="1"/>
            <p:nvPr/>
          </p:nvSpPr>
          <p:spPr>
            <a:xfrm rot="16200000">
              <a:off x="3393792" y="1146330"/>
              <a:ext cx="81752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id="{D69E6951-AEEF-7899-9688-370742044547}"/>
                </a:ext>
              </a:extLst>
            </p:cNvPr>
            <p:cNvSpPr txBox="1"/>
            <p:nvPr/>
          </p:nvSpPr>
          <p:spPr>
            <a:xfrm rot="16200000">
              <a:off x="1652252" y="1146330"/>
              <a:ext cx="81752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Gerader Verbinder 29">
              <a:extLst>
                <a:ext uri="{FF2B5EF4-FFF2-40B4-BE49-F238E27FC236}">
                  <a16:creationId xmlns:a16="http://schemas.microsoft.com/office/drawing/2014/main" id="{1B60227D-2587-E7C4-78AF-6B72207A36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43551" y="1007611"/>
              <a:ext cx="172002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r Verbinder 37">
              <a:extLst>
                <a:ext uri="{FF2B5EF4-FFF2-40B4-BE49-F238E27FC236}">
                  <a16:creationId xmlns:a16="http://schemas.microsoft.com/office/drawing/2014/main" id="{A52B8D8A-A3EE-97FC-F57A-DA0C770E90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24452" y="1007611"/>
              <a:ext cx="172002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r Verbinder 38">
              <a:extLst>
                <a:ext uri="{FF2B5EF4-FFF2-40B4-BE49-F238E27FC236}">
                  <a16:creationId xmlns:a16="http://schemas.microsoft.com/office/drawing/2014/main" id="{ACF8A12A-849A-FAFE-34E0-CC304AE08DB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02642" y="1739758"/>
              <a:ext cx="69752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Gerader Verbinder 39">
              <a:extLst>
                <a:ext uri="{FF2B5EF4-FFF2-40B4-BE49-F238E27FC236}">
                  <a16:creationId xmlns:a16="http://schemas.microsoft.com/office/drawing/2014/main" id="{6311AF1D-C137-8690-43B8-B1CDD4FD00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04831" y="1739758"/>
              <a:ext cx="69752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rader Verbinder 40">
              <a:extLst>
                <a:ext uri="{FF2B5EF4-FFF2-40B4-BE49-F238E27FC236}">
                  <a16:creationId xmlns:a16="http://schemas.microsoft.com/office/drawing/2014/main" id="{21CB2835-D2B4-271C-243A-EA897856624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09210" y="1739758"/>
              <a:ext cx="69752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B7F0FD24-A110-AC81-EA2B-2E5EBEC979B0}"/>
                </a:ext>
              </a:extLst>
            </p:cNvPr>
            <p:cNvSpPr txBox="1"/>
            <p:nvPr/>
          </p:nvSpPr>
          <p:spPr>
            <a:xfrm>
              <a:off x="518551" y="1222644"/>
              <a:ext cx="831630" cy="70788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de-DE" sz="200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W</a:t>
              </a:r>
            </a:p>
            <a:p>
              <a:pPr algn="ctr"/>
              <a:r>
                <a:rPr lang="de-DE" sz="200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de-DE" sz="200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de-DE" sz="2000" i="0" u="none" strike="noStrike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Da</a:t>
              </a:r>
              <a:r>
                <a:rPr lang="de-DE" sz="200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de-DE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06E402E2-5BC2-103D-068A-A7BF0FC41208}"/>
                </a:ext>
              </a:extLst>
            </p:cNvPr>
            <p:cNvSpPr txBox="1"/>
            <p:nvPr/>
          </p:nvSpPr>
          <p:spPr>
            <a:xfrm>
              <a:off x="5244577" y="3699622"/>
              <a:ext cx="1531535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sz="2000" i="0" u="none" strike="noStrike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granulysin</a:t>
              </a:r>
              <a:endParaRPr lang="de-DE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Gerader Verbinder 43">
              <a:extLst>
                <a:ext uri="{FF2B5EF4-FFF2-40B4-BE49-F238E27FC236}">
                  <a16:creationId xmlns:a16="http://schemas.microsoft.com/office/drawing/2014/main" id="{C13BCCE5-A354-F6E2-3669-86B6BBD2BF8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9190" y="3803746"/>
              <a:ext cx="30303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Gerader Verbinder 44">
              <a:extLst>
                <a:ext uri="{FF2B5EF4-FFF2-40B4-BE49-F238E27FC236}">
                  <a16:creationId xmlns:a16="http://schemas.microsoft.com/office/drawing/2014/main" id="{49192218-DF11-92A2-4AAD-DDF9B6841A3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9190" y="4351863"/>
              <a:ext cx="30303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Gerader Verbinder 45">
              <a:extLst>
                <a:ext uri="{FF2B5EF4-FFF2-40B4-BE49-F238E27FC236}">
                  <a16:creationId xmlns:a16="http://schemas.microsoft.com/office/drawing/2014/main" id="{FDBE9E43-23E6-DA4A-919A-CBCCA76FECA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9190" y="2561472"/>
              <a:ext cx="30303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Gerader Verbinder 46">
              <a:extLst>
                <a:ext uri="{FF2B5EF4-FFF2-40B4-BE49-F238E27FC236}">
                  <a16:creationId xmlns:a16="http://schemas.microsoft.com/office/drawing/2014/main" id="{096A41FB-C6FA-8107-65C8-2DD32789087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9190" y="2134491"/>
              <a:ext cx="30303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61531F5C-9B57-B7A1-DA09-D34E696F0A6A}"/>
                </a:ext>
              </a:extLst>
            </p:cNvPr>
            <p:cNvSpPr txBox="1"/>
            <p:nvPr/>
          </p:nvSpPr>
          <p:spPr>
            <a:xfrm>
              <a:off x="174750" y="1949825"/>
              <a:ext cx="94545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de-DE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C575A34A-E27C-E481-1E37-481F981A450C}"/>
                </a:ext>
              </a:extLst>
            </p:cNvPr>
            <p:cNvSpPr txBox="1"/>
            <p:nvPr/>
          </p:nvSpPr>
          <p:spPr>
            <a:xfrm>
              <a:off x="174750" y="2376806"/>
              <a:ext cx="94545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de-DE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feld 49">
              <a:extLst>
                <a:ext uri="{FF2B5EF4-FFF2-40B4-BE49-F238E27FC236}">
                  <a16:creationId xmlns:a16="http://schemas.microsoft.com/office/drawing/2014/main" id="{DCF68E70-87D6-346A-A379-C1C0280B4B38}"/>
                </a:ext>
              </a:extLst>
            </p:cNvPr>
            <p:cNvSpPr txBox="1"/>
            <p:nvPr/>
          </p:nvSpPr>
          <p:spPr>
            <a:xfrm>
              <a:off x="174750" y="3619080"/>
              <a:ext cx="94545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de-DE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feld 50">
              <a:extLst>
                <a:ext uri="{FF2B5EF4-FFF2-40B4-BE49-F238E27FC236}">
                  <a16:creationId xmlns:a16="http://schemas.microsoft.com/office/drawing/2014/main" id="{EDB01EC0-628B-CC51-1139-9C02B52BBE95}"/>
                </a:ext>
              </a:extLst>
            </p:cNvPr>
            <p:cNvSpPr txBox="1"/>
            <p:nvPr/>
          </p:nvSpPr>
          <p:spPr>
            <a:xfrm>
              <a:off x="174750" y="4167197"/>
              <a:ext cx="94545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de-DE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de-DE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de-DE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feld 51">
              <a:extLst>
                <a:ext uri="{FF2B5EF4-FFF2-40B4-BE49-F238E27FC236}">
                  <a16:creationId xmlns:a16="http://schemas.microsoft.com/office/drawing/2014/main" id="{03A15AC4-838E-8890-E425-A162B4A6334A}"/>
                </a:ext>
              </a:extLst>
            </p:cNvPr>
            <p:cNvSpPr txBox="1"/>
            <p:nvPr/>
          </p:nvSpPr>
          <p:spPr>
            <a:xfrm>
              <a:off x="5241807" y="2249303"/>
              <a:ext cx="1531535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sz="200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CD81</a:t>
              </a:r>
              <a:endParaRPr lang="de-DE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3">
            <a:extLst>
              <a:ext uri="{FF2B5EF4-FFF2-40B4-BE49-F238E27FC236}">
                <a16:creationId xmlns:a16="http://schemas.microsoft.com/office/drawing/2014/main" id="{BC015917-0693-7275-7B03-A074FF6F6E21}"/>
              </a:ext>
            </a:extLst>
          </p:cNvPr>
          <p:cNvSpPr txBox="1"/>
          <p:nvPr/>
        </p:nvSpPr>
        <p:spPr>
          <a:xfrm>
            <a:off x="653754" y="5609029"/>
            <a:ext cx="55530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S3 </a:t>
            </a:r>
            <a:r>
              <a:rPr lang="en-GB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– Detection of EV marker and effector proteins by Western blotting. 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CD8</a:t>
            </a:r>
            <a:r>
              <a:rPr lang="en-US" sz="900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+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 or </a:t>
            </a:r>
            <a:r>
              <a:rPr lang="de-DE" sz="9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γδ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 T cells 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ere lysed in NP-40 lysis buffer and  centrifuged at 4 °C and 14,000 rpm for ten minutes to get whole cell lysate (</a:t>
            </a:r>
            <a:r>
              <a:rPr lang="en-US" sz="9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cl</a:t>
            </a:r>
            <a:r>
              <a:rPr lang="en-US" sz="9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 Additionally, 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-5 µL of an EV preparation from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 CD8</a:t>
            </a:r>
            <a:r>
              <a:rPr lang="en-US" sz="900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+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 or </a:t>
            </a:r>
            <a:r>
              <a:rPr lang="de-DE" sz="9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γδ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 T cells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were suspended in NP-40 lysis buffer and processed for gel electrophoresis </a:t>
            </a:r>
            <a:r>
              <a:rPr lang="en-US" sz="9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n Bis-Tris </a:t>
            </a:r>
            <a:r>
              <a:rPr lang="en-US" sz="9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uPAGE</a:t>
            </a:r>
            <a:r>
              <a:rPr lang="en-US" sz="9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® gels (EV). Separated 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roteins were transferred to nitrocellulose and membranes blocked with BSA. Anti-CD81 (</a:t>
            </a:r>
            <a:r>
              <a:rPr lang="en-US" sz="9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5A6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and anti-</a:t>
            </a:r>
            <a:r>
              <a:rPr lang="en-US" sz="900" dirty="0" err="1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9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anulysin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DH2) antibodies </a:t>
            </a:r>
            <a:r>
              <a:rPr lang="en-US" sz="9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ere used with HRP-conjugated 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econdary antibodies for detection with enhanced chemiluminescence. Notably, </a:t>
            </a:r>
            <a:r>
              <a:rPr lang="en-US" sz="9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ranulysin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pecies present as distinct bands at 9-10 </a:t>
            </a:r>
            <a:r>
              <a:rPr lang="en-US" sz="9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15 </a:t>
            </a:r>
            <a:r>
              <a:rPr lang="en-US" sz="9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5866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3</Words>
  <Application>Microsoft Office PowerPoint</Application>
  <PresentationFormat>A4-Papier (210 x 297 mm)</PresentationFormat>
  <Paragraphs>16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ttmar Janssen</dc:creator>
  <cp:lastModifiedBy>Ottmar Janssen</cp:lastModifiedBy>
  <cp:revision>7</cp:revision>
  <dcterms:created xsi:type="dcterms:W3CDTF">2024-08-15T13:45:21Z</dcterms:created>
  <dcterms:modified xsi:type="dcterms:W3CDTF">2024-10-16T13:34:27Z</dcterms:modified>
</cp:coreProperties>
</file>